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handoutMasters/handoutMaster1.xml" ContentType="application/vnd.openxmlformats-officedocument.presentationml.handoutMaster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2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427" r:id="rId2"/>
  </p:sldIdLst>
  <p:sldSz cx="9144000" cy="6858000" type="screen4x3"/>
  <p:notesSz cx="6797675" cy="9926638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clrMru>
    <a:srgbClr val="008000"/>
    <a:srgbClr val="FF7C80"/>
    <a:srgbClr val="00CC66"/>
    <a:srgbClr val="FF6600"/>
    <a:srgbClr val="3399FF"/>
    <a:srgbClr val="FF9900"/>
    <a:srgbClr val="6600FF"/>
    <a:srgbClr val="66FFCC"/>
    <a:srgbClr val="66FFFF"/>
    <a:srgbClr val="66FF33"/>
  </p:clrMru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0518" autoAdjust="0"/>
    <p:restoredTop sz="84570" autoAdjust="0"/>
  </p:normalViewPr>
  <p:slideViewPr>
    <p:cSldViewPr>
      <p:cViewPr>
        <p:scale>
          <a:sx n="100" d="100"/>
          <a:sy n="100" d="100"/>
        </p:scale>
        <p:origin x="-1530" y="-276"/>
      </p:cViewPr>
      <p:guideLst>
        <p:guide orient="horz" pos="4009"/>
        <p:guide orient="horz" pos="3483"/>
        <p:guide orient="horz" pos="2499"/>
        <p:guide orient="horz" pos="2950"/>
        <p:guide orient="horz" pos="3552"/>
        <p:guide orient="horz" pos="3035"/>
        <p:guide pos="313"/>
        <p:guide pos="365"/>
        <p:guide pos="4202"/>
        <p:guide pos="4054"/>
        <p:guide pos="4740"/>
        <p:guide pos="3506"/>
        <p:guide pos="2894"/>
        <p:guide pos="3347"/>
        <p:guide pos="683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49" d="100"/>
          <a:sy n="49" d="100"/>
        </p:scale>
        <p:origin x="-1944" y="-102"/>
      </p:cViewPr>
      <p:guideLst>
        <p:guide orient="horz" pos="3126"/>
        <p:guide pos="2141"/>
      </p:guideLst>
    </p:cSldViewPr>
  </p:notes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CH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quarter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1179482-E1DB-40D8-9BCC-96E36A8D41C8}" type="datetimeFigureOut">
              <a:rPr lang="fr-CH" smtClean="0"/>
              <a:pPr/>
              <a:t>13.05.2013</a:t>
            </a:fld>
            <a:endParaRPr lang="fr-CH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2"/>
          </p:nvPr>
        </p:nvSpPr>
        <p:spPr>
          <a:xfrm>
            <a:off x="0" y="9428163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CH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3"/>
          </p:nvPr>
        </p:nvSpPr>
        <p:spPr>
          <a:xfrm>
            <a:off x="3849688" y="9428163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2BD1D8B-A891-4053-91D2-997344C7EEB8}" type="slidenum">
              <a:rPr lang="fr-CH" smtClean="0"/>
              <a:pPr/>
              <a:t>‹N°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xmlns="" val="1203306555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CH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E2D080D-7405-4136-AA98-F53C28D2E88F}" type="datetimeFigureOut">
              <a:rPr lang="fr-CH" smtClean="0"/>
              <a:pPr/>
              <a:t>13.05.2013</a:t>
            </a:fld>
            <a:endParaRPr lang="fr-CH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917575" y="744538"/>
            <a:ext cx="49625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CH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79768" y="4715153"/>
            <a:ext cx="5438140" cy="446698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H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CH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50443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273B8D3-2904-492A-9C30-94DE4CCC0DD5}" type="slidenum">
              <a:rPr lang="fr-CH" smtClean="0"/>
              <a:pPr/>
              <a:t>‹N°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xmlns="" val="122104748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fr-CH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CH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D3D19-4162-42BD-AECB-EC0369B8ACBB}" type="datetimeFigureOut">
              <a:rPr lang="fr-CH" smtClean="0"/>
              <a:pPr/>
              <a:t>13.05.2013</a:t>
            </a:fld>
            <a:endParaRPr lang="fr-CH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F7A06E-4570-48C7-827B-E6878AF93181}" type="slidenum">
              <a:rPr lang="fr-CH" smtClean="0"/>
              <a:pPr/>
              <a:t>‹N°›</a:t>
            </a:fld>
            <a:endParaRPr lang="fr-CH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CH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H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D3D19-4162-42BD-AECB-EC0369B8ACBB}" type="datetimeFigureOut">
              <a:rPr lang="fr-CH" smtClean="0"/>
              <a:pPr/>
              <a:t>13.05.2013</a:t>
            </a:fld>
            <a:endParaRPr lang="fr-CH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F7A06E-4570-48C7-827B-E6878AF93181}" type="slidenum">
              <a:rPr lang="fr-CH" smtClean="0"/>
              <a:pPr/>
              <a:t>‹N°›</a:t>
            </a:fld>
            <a:endParaRPr lang="fr-CH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fr-CH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H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D3D19-4162-42BD-AECB-EC0369B8ACBB}" type="datetimeFigureOut">
              <a:rPr lang="fr-CH" smtClean="0"/>
              <a:pPr/>
              <a:t>13.05.2013</a:t>
            </a:fld>
            <a:endParaRPr lang="fr-CH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F7A06E-4570-48C7-827B-E6878AF93181}" type="slidenum">
              <a:rPr lang="fr-CH" smtClean="0"/>
              <a:pPr/>
              <a:t>‹N°›</a:t>
            </a:fld>
            <a:endParaRPr lang="fr-CH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CH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H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D3D19-4162-42BD-AECB-EC0369B8ACBB}" type="datetimeFigureOut">
              <a:rPr lang="fr-CH" smtClean="0"/>
              <a:pPr/>
              <a:t>13.05.2013</a:t>
            </a:fld>
            <a:endParaRPr lang="fr-CH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F7A06E-4570-48C7-827B-E6878AF93181}" type="slidenum">
              <a:rPr lang="fr-CH" smtClean="0"/>
              <a:pPr/>
              <a:t>‹N°›</a:t>
            </a:fld>
            <a:endParaRPr lang="fr-CH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fr-CH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D3D19-4162-42BD-AECB-EC0369B8ACBB}" type="datetimeFigureOut">
              <a:rPr lang="fr-CH" smtClean="0"/>
              <a:pPr/>
              <a:t>13.05.2013</a:t>
            </a:fld>
            <a:endParaRPr lang="fr-CH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F7A06E-4570-48C7-827B-E6878AF93181}" type="slidenum">
              <a:rPr lang="fr-CH" smtClean="0"/>
              <a:pPr/>
              <a:t>‹N°›</a:t>
            </a:fld>
            <a:endParaRPr lang="fr-CH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CH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H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H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D3D19-4162-42BD-AECB-EC0369B8ACBB}" type="datetimeFigureOut">
              <a:rPr lang="fr-CH" smtClean="0"/>
              <a:pPr/>
              <a:t>13.05.2013</a:t>
            </a:fld>
            <a:endParaRPr lang="fr-CH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F7A06E-4570-48C7-827B-E6878AF93181}" type="slidenum">
              <a:rPr lang="fr-CH" smtClean="0"/>
              <a:pPr/>
              <a:t>‹N°›</a:t>
            </a:fld>
            <a:endParaRPr lang="fr-CH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fr-CH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H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H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D3D19-4162-42BD-AECB-EC0369B8ACBB}" type="datetimeFigureOut">
              <a:rPr lang="fr-CH" smtClean="0"/>
              <a:pPr/>
              <a:t>13.05.2013</a:t>
            </a:fld>
            <a:endParaRPr lang="fr-CH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F7A06E-4570-48C7-827B-E6878AF93181}" type="slidenum">
              <a:rPr lang="fr-CH" smtClean="0"/>
              <a:pPr/>
              <a:t>‹N°›</a:t>
            </a:fld>
            <a:endParaRPr lang="fr-CH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CH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D3D19-4162-42BD-AECB-EC0369B8ACBB}" type="datetimeFigureOut">
              <a:rPr lang="fr-CH" smtClean="0"/>
              <a:pPr/>
              <a:t>13.05.2013</a:t>
            </a:fld>
            <a:endParaRPr lang="fr-CH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F7A06E-4570-48C7-827B-E6878AF93181}" type="slidenum">
              <a:rPr lang="fr-CH" smtClean="0"/>
              <a:pPr/>
              <a:t>‹N°›</a:t>
            </a:fld>
            <a:endParaRPr lang="fr-CH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D3D19-4162-42BD-AECB-EC0369B8ACBB}" type="datetimeFigureOut">
              <a:rPr lang="fr-CH" smtClean="0"/>
              <a:pPr/>
              <a:t>13.05.2013</a:t>
            </a:fld>
            <a:endParaRPr lang="fr-CH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F7A06E-4570-48C7-827B-E6878AF93181}" type="slidenum">
              <a:rPr lang="fr-CH" smtClean="0"/>
              <a:pPr/>
              <a:t>‹N°›</a:t>
            </a:fld>
            <a:endParaRPr lang="fr-CH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CH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H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D3D19-4162-42BD-AECB-EC0369B8ACBB}" type="datetimeFigureOut">
              <a:rPr lang="fr-CH" smtClean="0"/>
              <a:pPr/>
              <a:t>13.05.2013</a:t>
            </a:fld>
            <a:endParaRPr lang="fr-CH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F7A06E-4570-48C7-827B-E6878AF93181}" type="slidenum">
              <a:rPr lang="fr-CH" smtClean="0"/>
              <a:pPr/>
              <a:t>‹N°›</a:t>
            </a:fld>
            <a:endParaRPr lang="fr-CH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CH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CH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D3D19-4162-42BD-AECB-EC0369B8ACBB}" type="datetimeFigureOut">
              <a:rPr lang="fr-CH" smtClean="0"/>
              <a:pPr/>
              <a:t>13.05.2013</a:t>
            </a:fld>
            <a:endParaRPr lang="fr-CH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F7A06E-4570-48C7-827B-E6878AF93181}" type="slidenum">
              <a:rPr lang="fr-CH" smtClean="0"/>
              <a:pPr/>
              <a:t>‹N°›</a:t>
            </a:fld>
            <a:endParaRPr lang="fr-CH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fr-CH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H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CD3D19-4162-42BD-AECB-EC0369B8ACBB}" type="datetimeFigureOut">
              <a:rPr lang="fr-CH" smtClean="0"/>
              <a:pPr/>
              <a:t>13.05.2013</a:t>
            </a:fld>
            <a:endParaRPr lang="fr-CH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CH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F7A06E-4570-48C7-827B-E6878AF93181}" type="slidenum">
              <a:rPr lang="fr-CH" smtClean="0"/>
              <a:pPr/>
              <a:t>‹N°›</a:t>
            </a:fld>
            <a:endParaRPr lang="fr-CH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/>
          <p:cNvSpPr txBox="1"/>
          <p:nvPr/>
        </p:nvSpPr>
        <p:spPr>
          <a:xfrm>
            <a:off x="479250" y="836712"/>
            <a:ext cx="68284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H" sz="1200" b="1" dirty="0" smtClean="0">
                <a:latin typeface="Arial" pitchFamily="34" charset="0"/>
                <a:cs typeface="Arial" pitchFamily="34" charset="0"/>
              </a:rPr>
              <a:t>Table S1: Clinical and </a:t>
            </a:r>
            <a:r>
              <a:rPr lang="fr-CH" sz="1200" b="1" dirty="0" err="1" smtClean="0">
                <a:latin typeface="Arial" pitchFamily="34" charset="0"/>
                <a:cs typeface="Arial" pitchFamily="34" charset="0"/>
              </a:rPr>
              <a:t>virological</a:t>
            </a:r>
            <a:r>
              <a:rPr lang="fr-CH" sz="1200" b="1" dirty="0" smtClean="0">
                <a:latin typeface="Arial" pitchFamily="34" charset="0"/>
                <a:cs typeface="Arial" pitchFamily="34" charset="0"/>
              </a:rPr>
              <a:t> description of the distinct </a:t>
            </a:r>
            <a:r>
              <a:rPr lang="fr-CH" sz="1200" b="1" dirty="0" err="1" smtClean="0">
                <a:latin typeface="Arial" pitchFamily="34" charset="0"/>
                <a:cs typeface="Arial" pitchFamily="34" charset="0"/>
              </a:rPr>
              <a:t>cohorts</a:t>
            </a:r>
            <a:r>
              <a:rPr lang="fr-CH" sz="1200" b="1" dirty="0" smtClean="0">
                <a:latin typeface="Arial" pitchFamily="34" charset="0"/>
                <a:cs typeface="Arial" pitchFamily="34" charset="0"/>
              </a:rPr>
              <a:t> of HIV-</a:t>
            </a:r>
            <a:r>
              <a:rPr lang="fr-CH" sz="1200" b="1" dirty="0" err="1" smtClean="0">
                <a:latin typeface="Arial" pitchFamily="34" charset="0"/>
                <a:cs typeface="Arial" pitchFamily="34" charset="0"/>
              </a:rPr>
              <a:t>infected</a:t>
            </a:r>
            <a:r>
              <a:rPr lang="fr-CH" sz="1200" b="1" dirty="0" smtClean="0">
                <a:latin typeface="Arial" pitchFamily="34" charset="0"/>
                <a:cs typeface="Arial" pitchFamily="34" charset="0"/>
              </a:rPr>
              <a:t> patients</a:t>
            </a:r>
            <a:endParaRPr lang="fr-CH" sz="12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509588" y="1087438"/>
            <a:ext cx="8124825" cy="3886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7674</TotalTime>
  <Words>14</Words>
  <Application>Microsoft Office PowerPoint</Application>
  <PresentationFormat>Affichage à l'écran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Diapositive 1</vt:lpstr>
    </vt:vector>
  </TitlesOfParts>
  <Company>CHUV | Centre hospitalier universitaire vaudois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svigano</dc:creator>
  <cp:lastModifiedBy>Informatique</cp:lastModifiedBy>
  <cp:revision>3803</cp:revision>
  <dcterms:created xsi:type="dcterms:W3CDTF">2010-12-07T17:02:01Z</dcterms:created>
  <dcterms:modified xsi:type="dcterms:W3CDTF">2013-05-13T07:58:45Z</dcterms:modified>
</cp:coreProperties>
</file>